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7310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62063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51020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39976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628933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7433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4382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51331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48281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45230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42179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39128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360775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33026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29975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26924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23873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20823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594369" y="17772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94369" y="14721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594369" y="11670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31758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406541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495498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58445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406541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5756341" y="11670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4541397" y="1167042"/>
              <a:ext cx="1214944" cy="0"/>
            </a:xfrm>
            <a:custGeom>
              <a:avLst/>
              <a:pathLst>
                <a:path w="1214944" h="0">
                  <a:moveTo>
                    <a:pt x="121494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4541397" y="11670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5106502" y="2997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3970575" y="2997575"/>
              <a:ext cx="1135926" cy="0"/>
            </a:xfrm>
            <a:custGeom>
              <a:avLst/>
              <a:pathLst>
                <a:path w="1135926" h="0">
                  <a:moveTo>
                    <a:pt x="11359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3970575" y="2997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5506008" y="2387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4219782" y="2387398"/>
              <a:ext cx="1286226" cy="0"/>
            </a:xfrm>
            <a:custGeom>
              <a:avLst/>
              <a:pathLst>
                <a:path w="1286226" h="0">
                  <a:moveTo>
                    <a:pt x="12862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4219782" y="2387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5677108" y="1472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4523461" y="1472131"/>
              <a:ext cx="1153646" cy="0"/>
            </a:xfrm>
            <a:custGeom>
              <a:avLst/>
              <a:pathLst>
                <a:path w="1153646" h="0">
                  <a:moveTo>
                    <a:pt x="11536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4523461" y="1472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4762860" y="3912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3725334" y="3912842"/>
              <a:ext cx="1037525" cy="0"/>
            </a:xfrm>
            <a:custGeom>
              <a:avLst/>
              <a:pathLst>
                <a:path w="1037525" h="0">
                  <a:moveTo>
                    <a:pt x="10375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725334" y="3912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4414511" y="45230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315586" y="4523020"/>
              <a:ext cx="1098924" cy="0"/>
            </a:xfrm>
            <a:custGeom>
              <a:avLst/>
              <a:pathLst>
                <a:path w="1098924" h="0">
                  <a:moveTo>
                    <a:pt x="10989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3315586" y="45230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4890268" y="3607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3747167" y="3607753"/>
              <a:ext cx="1143100" cy="0"/>
            </a:xfrm>
            <a:custGeom>
              <a:avLst/>
              <a:pathLst>
                <a:path w="1143100" h="0">
                  <a:moveTo>
                    <a:pt x="11431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3747167" y="3607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4411520" y="4828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764225" y="4828109"/>
              <a:ext cx="1647294" cy="0"/>
            </a:xfrm>
            <a:custGeom>
              <a:avLst/>
              <a:pathLst>
                <a:path w="1647294" h="0">
                  <a:moveTo>
                    <a:pt x="16472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764225" y="4828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5197238" y="26924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4252022" y="2692486"/>
              <a:ext cx="945215" cy="0"/>
            </a:xfrm>
            <a:custGeom>
              <a:avLst/>
              <a:pathLst>
                <a:path w="945215" h="0">
                  <a:moveTo>
                    <a:pt x="9452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4252022" y="26924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6161354" y="17772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3743923" y="1777220"/>
              <a:ext cx="2417430" cy="0"/>
            </a:xfrm>
            <a:custGeom>
              <a:avLst/>
              <a:pathLst>
                <a:path w="2417430" h="0">
                  <a:moveTo>
                    <a:pt x="24174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3743923" y="17772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4812108" y="3302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4134654" y="3302664"/>
              <a:ext cx="677454" cy="0"/>
            </a:xfrm>
            <a:custGeom>
              <a:avLst/>
              <a:pathLst>
                <a:path w="677454" h="0">
                  <a:moveTo>
                    <a:pt x="6774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4134654" y="3302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4567663" y="4217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3640369" y="4217931"/>
              <a:ext cx="927293" cy="0"/>
            </a:xfrm>
            <a:custGeom>
              <a:avLst/>
              <a:pathLst>
                <a:path w="927293" h="0">
                  <a:moveTo>
                    <a:pt x="9272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3640369" y="4217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5587332" y="2082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4299808" y="2082309"/>
              <a:ext cx="1287524" cy="0"/>
            </a:xfrm>
            <a:custGeom>
              <a:avLst/>
              <a:pathLst>
                <a:path w="1287524" h="0">
                  <a:moveTo>
                    <a:pt x="12875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4299808" y="2082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4724936" y="5743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4271297" y="5743376"/>
              <a:ext cx="453638" cy="0"/>
            </a:xfrm>
            <a:custGeom>
              <a:avLst/>
              <a:pathLst>
                <a:path w="453638" h="0">
                  <a:moveTo>
                    <a:pt x="453638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4271297" y="5743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5665044" y="5438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2982853" y="5438287"/>
              <a:ext cx="2682191" cy="0"/>
            </a:xfrm>
            <a:custGeom>
              <a:avLst/>
              <a:pathLst>
                <a:path w="2682191" h="0">
                  <a:moveTo>
                    <a:pt x="2682191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2982853" y="5438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t77"/>
            <p:cNvSpPr/>
            <p:nvPr/>
          </p:nvSpPr>
          <p:spPr>
            <a:xfrm>
              <a:off x="5124043" y="11422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t78"/>
            <p:cNvSpPr/>
            <p:nvPr/>
          </p:nvSpPr>
          <p:spPr>
            <a:xfrm>
              <a:off x="4513713" y="29727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t79"/>
            <p:cNvSpPr/>
            <p:nvPr/>
          </p:nvSpPr>
          <p:spPr>
            <a:xfrm>
              <a:off x="4838069" y="23625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t80"/>
            <p:cNvSpPr/>
            <p:nvPr/>
          </p:nvSpPr>
          <p:spPr>
            <a:xfrm>
              <a:off x="5075458" y="14473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t81"/>
            <p:cNvSpPr/>
            <p:nvPr/>
          </p:nvSpPr>
          <p:spPr>
            <a:xfrm>
              <a:off x="4219271" y="38880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t82"/>
            <p:cNvSpPr/>
            <p:nvPr/>
          </p:nvSpPr>
          <p:spPr>
            <a:xfrm>
              <a:off x="3840223" y="44981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t83"/>
            <p:cNvSpPr/>
            <p:nvPr/>
          </p:nvSpPr>
          <p:spPr>
            <a:xfrm>
              <a:off x="4293892" y="35829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t84"/>
            <p:cNvSpPr/>
            <p:nvPr/>
          </p:nvSpPr>
          <p:spPr>
            <a:xfrm>
              <a:off x="3563047" y="48032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t85"/>
            <p:cNvSpPr/>
            <p:nvPr/>
          </p:nvSpPr>
          <p:spPr>
            <a:xfrm>
              <a:off x="4699804" y="26676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t86"/>
            <p:cNvSpPr/>
            <p:nvPr/>
          </p:nvSpPr>
          <p:spPr>
            <a:xfrm>
              <a:off x="4927813" y="17523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t87"/>
            <p:cNvSpPr/>
            <p:nvPr/>
          </p:nvSpPr>
          <p:spPr>
            <a:xfrm>
              <a:off x="4448555" y="32778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t88"/>
            <p:cNvSpPr/>
            <p:nvPr/>
          </p:nvSpPr>
          <p:spPr>
            <a:xfrm>
              <a:off x="4079190" y="41931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t89"/>
            <p:cNvSpPr/>
            <p:nvPr/>
          </p:nvSpPr>
          <p:spPr>
            <a:xfrm>
              <a:off x="4918744" y="20574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t90"/>
            <p:cNvSpPr/>
            <p:nvPr/>
          </p:nvSpPr>
          <p:spPr>
            <a:xfrm>
              <a:off x="4473291" y="5718550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t91"/>
            <p:cNvSpPr/>
            <p:nvPr/>
          </p:nvSpPr>
          <p:spPr>
            <a:xfrm>
              <a:off x="4299123" y="5413461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594369" y="51331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tx93"/>
            <p:cNvSpPr/>
            <p:nvPr/>
          </p:nvSpPr>
          <p:spPr>
            <a:xfrm>
              <a:off x="1148183" y="5685630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95" name="tx94"/>
            <p:cNvSpPr/>
            <p:nvPr/>
          </p:nvSpPr>
          <p:spPr>
            <a:xfrm>
              <a:off x="1871190" y="5380541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96" name="tx95"/>
            <p:cNvSpPr/>
            <p:nvPr/>
          </p:nvSpPr>
          <p:spPr>
            <a:xfrm>
              <a:off x="2051570" y="479015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86375</a:t>
              </a:r>
            </a:p>
          </p:txBody>
        </p:sp>
        <p:sp>
          <p:nvSpPr>
            <p:cNvPr id="97" name="tx96"/>
            <p:cNvSpPr/>
            <p:nvPr/>
          </p:nvSpPr>
          <p:spPr>
            <a:xfrm>
              <a:off x="2164580" y="4485069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111</a:t>
              </a:r>
            </a:p>
          </p:txBody>
        </p:sp>
        <p:sp>
          <p:nvSpPr>
            <p:cNvPr id="98" name="tx97"/>
            <p:cNvSpPr/>
            <p:nvPr/>
          </p:nvSpPr>
          <p:spPr>
            <a:xfrm>
              <a:off x="2051570" y="418002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42820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2051570" y="387494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85585</a:t>
              </a:r>
            </a:p>
          </p:txBody>
        </p:sp>
        <p:sp>
          <p:nvSpPr>
            <p:cNvPr id="100" name="tx99"/>
            <p:cNvSpPr/>
            <p:nvPr/>
          </p:nvSpPr>
          <p:spPr>
            <a:xfrm>
              <a:off x="2108075" y="356985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2680</a:t>
              </a:r>
            </a:p>
          </p:txBody>
        </p:sp>
        <p:sp>
          <p:nvSpPr>
            <p:cNvPr id="101" name="tx100"/>
            <p:cNvSpPr/>
            <p:nvPr/>
          </p:nvSpPr>
          <p:spPr>
            <a:xfrm>
              <a:off x="2051570" y="326476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42772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051570" y="295967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69481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2108075" y="2654585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1995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2051570" y="234944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17939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2108075" y="204440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8714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1995065" y="173926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8313928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108075" y="1434180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673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1995065" y="112914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65727</a:t>
              </a:r>
            </a:p>
          </p:txBody>
        </p:sp>
        <p:sp>
          <p:nvSpPr>
            <p:cNvPr id="109" name="pl108"/>
            <p:cNvSpPr/>
            <p:nvPr/>
          </p:nvSpPr>
          <p:spPr>
            <a:xfrm>
              <a:off x="2559574" y="57433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559574" y="54382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559574" y="51331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2559574" y="48281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2559574" y="45230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2559574" y="42179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559574" y="39128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2559574" y="36077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559574" y="33026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559574" y="29975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559574" y="26924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559574" y="23873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559574" y="20823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2559574" y="17772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559574" y="14721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559574" y="11670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317585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406541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495498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584455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tx128"/>
            <p:cNvSpPr/>
            <p:nvPr/>
          </p:nvSpPr>
          <p:spPr>
            <a:xfrm>
              <a:off x="3079562" y="5987367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5</a:t>
              </a:r>
            </a:p>
          </p:txBody>
        </p:sp>
        <p:sp>
          <p:nvSpPr>
            <p:cNvPr id="130" name="tx129"/>
            <p:cNvSpPr/>
            <p:nvPr/>
          </p:nvSpPr>
          <p:spPr>
            <a:xfrm>
              <a:off x="3987737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131" name="tx130"/>
            <p:cNvSpPr/>
            <p:nvPr/>
          </p:nvSpPr>
          <p:spPr>
            <a:xfrm>
              <a:off x="4877303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132" name="tx131"/>
            <p:cNvSpPr/>
            <p:nvPr/>
          </p:nvSpPr>
          <p:spPr>
            <a:xfrm>
              <a:off x="5766870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</a:t>
              </a:r>
            </a:p>
          </p:txBody>
        </p:sp>
        <p:sp>
          <p:nvSpPr>
            <p:cNvPr id="133" name="tx132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134" name="tx133"/>
            <p:cNvSpPr/>
            <p:nvPr/>
          </p:nvSpPr>
          <p:spPr>
            <a:xfrm>
              <a:off x="2569622" y="6214430"/>
              <a:ext cx="3786336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|| id:ebi-a-GCST006095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2:09:49Z</dcterms:modified>
  <cp:category/>
</cp:coreProperties>
</file>